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937895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5304" autoAdjust="0"/>
  </p:normalViewPr>
  <p:slideViewPr>
    <p:cSldViewPr>
      <p:cViewPr>
        <p:scale>
          <a:sx n="100" d="100"/>
          <a:sy n="100" d="100"/>
        </p:scale>
        <p:origin x="-894" y="648"/>
      </p:cViewPr>
      <p:guideLst>
        <p:guide orient="horz" pos="295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913556"/>
            <a:ext cx="7772400" cy="201039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5314738"/>
            <a:ext cx="6400800" cy="239684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375595"/>
            <a:ext cx="2057400" cy="800250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375595"/>
            <a:ext cx="6019800" cy="800250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6026846"/>
            <a:ext cx="7772400" cy="1862764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3975201"/>
            <a:ext cx="7772400" cy="205164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2188423"/>
            <a:ext cx="4038600" cy="618967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2188423"/>
            <a:ext cx="4038600" cy="618967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2099409"/>
            <a:ext cx="4040188" cy="8749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974343"/>
            <a:ext cx="4040188" cy="540375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8" y="2099409"/>
            <a:ext cx="4041775" cy="8749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8" y="2974343"/>
            <a:ext cx="4041775" cy="540375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3" y="373421"/>
            <a:ext cx="3008313" cy="158921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373422"/>
            <a:ext cx="5111750" cy="800467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3" y="1962633"/>
            <a:ext cx="3008313" cy="64154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6565265"/>
            <a:ext cx="5486400" cy="77506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838027"/>
            <a:ext cx="5486400" cy="562737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7340332"/>
            <a:ext cx="5486400" cy="11007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375593"/>
            <a:ext cx="8229600" cy="15631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2188423"/>
            <a:ext cx="8229600" cy="61896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8692899"/>
            <a:ext cx="2133600" cy="4993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8692899"/>
            <a:ext cx="2895600" cy="4993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8692899"/>
            <a:ext cx="2133600" cy="4993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129918" y="132720"/>
            <a:ext cx="8351222" cy="8708776"/>
            <a:chOff x="129918" y="132720"/>
            <a:chExt cx="8351222" cy="8708776"/>
          </a:xfrm>
        </p:grpSpPr>
        <p:pic>
          <p:nvPicPr>
            <p:cNvPr id="7" name="图片 6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21" t="14651" r="11649" b="6915"/>
            <a:stretch/>
          </p:blipFill>
          <p:spPr bwMode="auto">
            <a:xfrm>
              <a:off x="437695" y="305633"/>
              <a:ext cx="1943554" cy="193555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8" name="图片 7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27" t="14998" r="13668" b="6568"/>
            <a:stretch/>
          </p:blipFill>
          <p:spPr bwMode="auto">
            <a:xfrm>
              <a:off x="2367531" y="315157"/>
              <a:ext cx="1948997" cy="193555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" name="图片 9"/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47" t="15158" r="11670" b="6780"/>
            <a:stretch/>
          </p:blipFill>
          <p:spPr bwMode="auto">
            <a:xfrm>
              <a:off x="489644" y="2452024"/>
              <a:ext cx="1877887" cy="195648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图片 10"/>
            <p:cNvPicPr/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24" t="16546" r="17695" b="6448"/>
            <a:stretch/>
          </p:blipFill>
          <p:spPr bwMode="auto">
            <a:xfrm>
              <a:off x="4382935" y="315157"/>
              <a:ext cx="1772362" cy="193555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图片 11"/>
            <p:cNvPicPr/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70" t="14621" r="12271" b="6782"/>
            <a:stretch/>
          </p:blipFill>
          <p:spPr bwMode="auto">
            <a:xfrm>
              <a:off x="6457496" y="267049"/>
              <a:ext cx="1942076" cy="197413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" name="图片 12"/>
            <p:cNvPicPr/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26" t="14998" r="11777" b="6940"/>
            <a:stretch/>
          </p:blipFill>
          <p:spPr bwMode="auto">
            <a:xfrm>
              <a:off x="2439953" y="2452024"/>
              <a:ext cx="1935279" cy="195648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4" name="图片 13"/>
            <p:cNvPicPr/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34" t="15615" r="11454" b="6323"/>
            <a:stretch/>
          </p:blipFill>
          <p:spPr bwMode="auto">
            <a:xfrm>
              <a:off x="4393098" y="2467629"/>
              <a:ext cx="1967639" cy="195648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" name="图片 14"/>
            <p:cNvPicPr/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70" t="13902" r="12270" b="8036"/>
            <a:stretch/>
          </p:blipFill>
          <p:spPr bwMode="auto">
            <a:xfrm>
              <a:off x="6475355" y="2404555"/>
              <a:ext cx="1942076" cy="195648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" name="图片 15"/>
            <p:cNvPicPr/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81" t="14998" r="12528" b="8047"/>
            <a:stretch/>
          </p:blipFill>
          <p:spPr bwMode="auto">
            <a:xfrm>
              <a:off x="489644" y="4643076"/>
              <a:ext cx="1933200" cy="190157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" name="图片 17"/>
            <p:cNvPicPr/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71" t="14998" r="13400" b="8047"/>
            <a:stretch/>
          </p:blipFill>
          <p:spPr bwMode="auto">
            <a:xfrm>
              <a:off x="2475956" y="4656694"/>
              <a:ext cx="1863272" cy="188795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" name="图片 18"/>
            <p:cNvPicPr/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61" t="14998" r="13400" b="8980"/>
            <a:stretch/>
          </p:blipFill>
          <p:spPr bwMode="auto">
            <a:xfrm>
              <a:off x="4439538" y="4677948"/>
              <a:ext cx="1858622" cy="183183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0" name="矩形 19"/>
            <p:cNvSpPr/>
            <p:nvPr/>
          </p:nvSpPr>
          <p:spPr>
            <a:xfrm>
              <a:off x="1186192" y="1323357"/>
              <a:ext cx="124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0.93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9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0.9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</a:t>
              </a: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0.800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3158623" y="1307490"/>
              <a:ext cx="1157905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0.978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pPr algn="just"/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9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pPr algn="just"/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1.0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pPr algn="just"/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0.90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>
              <a:off x="5178083" y="1282933"/>
              <a:ext cx="1180863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0.908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8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1.0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0.80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>
              <a:off x="7243931" y="1282933"/>
              <a:ext cx="1117663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0.902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9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0.8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0.700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1169585" y="3537347"/>
              <a:ext cx="1062294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0.945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8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0.9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</a:t>
              </a: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0.800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3127713" y="3551768"/>
              <a:ext cx="1116809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0.93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9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Specificity  </a:t>
              </a: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0.9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0.85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>
              <a:off x="5162093" y="3551768"/>
              <a:ext cx="1164978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 0.9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9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0.9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</a:t>
              </a: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0.90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7281909" y="3551767"/>
              <a:ext cx="1117663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 </a:t>
              </a: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0.957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8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1.0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</a:t>
              </a: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0.850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>
              <a:off x="1230323" y="5727534"/>
              <a:ext cx="1001556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0.913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8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0.9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Accuracy    </a:t>
              </a:r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0.75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>
              <a:off x="3223189" y="5697587"/>
              <a:ext cx="1116808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   0.87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9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0.8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0.75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>
              <a:off x="5178083" y="5693516"/>
              <a:ext cx="1095474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0.89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0.8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Specificity   0.9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ccuracy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0.70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932102" y="159327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1430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821368" y="132720"/>
              <a:ext cx="8954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159a.2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956376" y="2296833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169d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021772" y="147407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164c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871296" y="2296833"/>
              <a:ext cx="13732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172d-5p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852362" y="157562"/>
              <a:ext cx="14442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156b-3p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26" t="15191" r="16514" b="6907"/>
            <a:stretch/>
          </p:blipFill>
          <p:spPr bwMode="auto">
            <a:xfrm>
              <a:off x="6525698" y="4677949"/>
              <a:ext cx="1738069" cy="18667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0" name="矩形 39"/>
            <p:cNvSpPr/>
            <p:nvPr/>
          </p:nvSpPr>
          <p:spPr>
            <a:xfrm>
              <a:off x="7241140" y="5697587"/>
              <a:ext cx="124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 0.931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0.8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0.9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Accuracy    0.80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58" t="14783" r="14329" b="6600"/>
            <a:stretch/>
          </p:blipFill>
          <p:spPr bwMode="auto">
            <a:xfrm>
              <a:off x="529333" y="6827438"/>
              <a:ext cx="1792775" cy="17986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" name="矩形 40"/>
            <p:cNvSpPr/>
            <p:nvPr/>
          </p:nvSpPr>
          <p:spPr>
            <a:xfrm>
              <a:off x="1318704" y="7751603"/>
              <a:ext cx="124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AUC    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     0.986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ensitivity  </a:t>
              </a:r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0.90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>
                  <a:latin typeface="Arial" pitchFamily="34" charset="0"/>
                  <a:cs typeface="Arial" pitchFamily="34" charset="0"/>
                </a:rPr>
                <a:t>Specificity  0.950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Accuracy    0.850 </a:t>
              </a:r>
              <a:endParaRPr lang="zh-CN" altLang="zh-CN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900514" y="2297825"/>
              <a:ext cx="13730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smtClean="0">
                  <a:latin typeface="Arial" pitchFamily="34" charset="0"/>
                  <a:cs typeface="Arial" pitchFamily="34" charset="0"/>
                </a:rPr>
                <a:t>osa-miR319a-3p 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995323" y="2296833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395a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007743" y="6719716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812q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075446" y="4535354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396g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972169" y="4535354"/>
              <a:ext cx="12674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444b.1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974967" y="4535354"/>
              <a:ext cx="12985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528-3p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995323" y="4535354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osa-miR529a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4003117" y="8626052"/>
              <a:ext cx="13862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1-Specificity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 rot="10800000">
              <a:off x="129918" y="3636577"/>
              <a:ext cx="307777" cy="113113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Sensitivity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94098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8</TotalTime>
  <Words>119</Words>
  <Application>Microsoft Office PowerPoint</Application>
  <PresentationFormat>自定义</PresentationFormat>
  <Paragraphs>6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Jia</dc:creator>
  <cp:lastModifiedBy>JiaJia</cp:lastModifiedBy>
  <cp:revision>13</cp:revision>
  <dcterms:created xsi:type="dcterms:W3CDTF">2016-11-29T07:48:52Z</dcterms:created>
  <dcterms:modified xsi:type="dcterms:W3CDTF">2018-09-12T11:58:34Z</dcterms:modified>
</cp:coreProperties>
</file>